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40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ishida\Documents\PLoS%20ONE%200916\TableS2(2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plotArea>
      <c:layout/>
      <c:barChart>
        <c:barDir val="bar"/>
        <c:grouping val="clustered"/>
        <c:ser>
          <c:idx val="0"/>
          <c:order val="0"/>
          <c:tx>
            <c:strRef>
              <c:f>Sheet1!$A$7</c:f>
              <c:strCache>
                <c:ptCount val="1"/>
                <c:pt idx="0">
                  <c:v>ELP3 deletion</c:v>
                </c:pt>
              </c:strCache>
            </c:strRef>
          </c:tx>
          <c:cat>
            <c:strRef>
              <c:f>Sheet1!$B$6:$W$6</c:f>
              <c:strCache>
                <c:ptCount val="22"/>
                <c:pt idx="0">
                  <c:v>YBL003C</c:v>
                </c:pt>
                <c:pt idx="1">
                  <c:v>YBL002W</c:v>
                </c:pt>
                <c:pt idx="2">
                  <c:v>YBR018C</c:v>
                </c:pt>
                <c:pt idx="3">
                  <c:v>YBR048W</c:v>
                </c:pt>
                <c:pt idx="4">
                  <c:v>YCR099C</c:v>
                </c:pt>
                <c:pt idx="5">
                  <c:v>YDR389W</c:v>
                </c:pt>
                <c:pt idx="6">
                  <c:v>YDR525W-A</c:v>
                </c:pt>
                <c:pt idx="7">
                  <c:v>YFL033C</c:v>
                </c:pt>
                <c:pt idx="8">
                  <c:v>YGR211W</c:v>
                </c:pt>
                <c:pt idx="9">
                  <c:v>YHR011W</c:v>
                </c:pt>
                <c:pt idx="10">
                  <c:v>YIL052C</c:v>
                </c:pt>
                <c:pt idx="11">
                  <c:v>YLL026W</c:v>
                </c:pt>
                <c:pt idx="12">
                  <c:v>YLR438C-A</c:v>
                </c:pt>
                <c:pt idx="13">
                  <c:v>YLR464W</c:v>
                </c:pt>
                <c:pt idx="14">
                  <c:v>YMR032W</c:v>
                </c:pt>
                <c:pt idx="15">
                  <c:v>YMR104C</c:v>
                </c:pt>
                <c:pt idx="16">
                  <c:v>YNL336W</c:v>
                </c:pt>
                <c:pt idx="17">
                  <c:v>YNL269W</c:v>
                </c:pt>
                <c:pt idx="18">
                  <c:v>YNR062C</c:v>
                </c:pt>
                <c:pt idx="19">
                  <c:v>YOR140W</c:v>
                </c:pt>
                <c:pt idx="20">
                  <c:v>YOR262W</c:v>
                </c:pt>
                <c:pt idx="21">
                  <c:v>YOR356W</c:v>
                </c:pt>
              </c:strCache>
            </c:strRef>
          </c:cat>
          <c:val>
            <c:numRef>
              <c:f>Sheet1!$B$7:$W$7</c:f>
              <c:numCache>
                <c:formatCode>General</c:formatCode>
                <c:ptCount val="22"/>
                <c:pt idx="0">
                  <c:v>0.35230576796417784</c:v>
                </c:pt>
                <c:pt idx="1">
                  <c:v>0.41148164991629443</c:v>
                </c:pt>
                <c:pt idx="2">
                  <c:v>0.38920442019128665</c:v>
                </c:pt>
                <c:pt idx="3">
                  <c:v>1.070882357083502</c:v>
                </c:pt>
                <c:pt idx="4">
                  <c:v>0.61238039429871916</c:v>
                </c:pt>
                <c:pt idx="5">
                  <c:v>0.262884320248502</c:v>
                </c:pt>
                <c:pt idx="6">
                  <c:v>0.76096394259046929</c:v>
                </c:pt>
                <c:pt idx="7">
                  <c:v>0.69635747083988708</c:v>
                </c:pt>
                <c:pt idx="8">
                  <c:v>0.42144024660197738</c:v>
                </c:pt>
                <c:pt idx="9">
                  <c:v>0.50648800231793056</c:v>
                </c:pt>
                <c:pt idx="10">
                  <c:v>0.84604130224159757</c:v>
                </c:pt>
                <c:pt idx="11">
                  <c:v>1.0566517694976796</c:v>
                </c:pt>
                <c:pt idx="12">
                  <c:v>0.78998655227043779</c:v>
                </c:pt>
                <c:pt idx="13">
                  <c:v>0.52671702595428227</c:v>
                </c:pt>
                <c:pt idx="14">
                  <c:v>0.35843911834667774</c:v>
                </c:pt>
                <c:pt idx="15">
                  <c:v>0.77512452210172178</c:v>
                </c:pt>
                <c:pt idx="16">
                  <c:v>0.71528991204153392</c:v>
                </c:pt>
                <c:pt idx="17">
                  <c:v>1.2636526909582819</c:v>
                </c:pt>
                <c:pt idx="18">
                  <c:v>0.27419990948732759</c:v>
                </c:pt>
                <c:pt idx="19">
                  <c:v>0.51153327685348959</c:v>
                </c:pt>
                <c:pt idx="20">
                  <c:v>0.70397690255323853</c:v>
                </c:pt>
                <c:pt idx="21">
                  <c:v>0.61518831250219153</c:v>
                </c:pt>
              </c:numCache>
            </c:numRef>
          </c:val>
        </c:ser>
        <c:ser>
          <c:idx val="1"/>
          <c:order val="1"/>
          <c:tx>
            <c:strRef>
              <c:f>Sheet1!$A$8</c:f>
              <c:strCache>
                <c:ptCount val="1"/>
                <c:pt idx="0">
                  <c:v>HOS2 deletion</c:v>
                </c:pt>
              </c:strCache>
            </c:strRef>
          </c:tx>
          <c:cat>
            <c:strRef>
              <c:f>Sheet1!$B$6:$W$6</c:f>
              <c:strCache>
                <c:ptCount val="22"/>
                <c:pt idx="0">
                  <c:v>YBL003C</c:v>
                </c:pt>
                <c:pt idx="1">
                  <c:v>YBL002W</c:v>
                </c:pt>
                <c:pt idx="2">
                  <c:v>YBR018C</c:v>
                </c:pt>
                <c:pt idx="3">
                  <c:v>YBR048W</c:v>
                </c:pt>
                <c:pt idx="4">
                  <c:v>YCR099C</c:v>
                </c:pt>
                <c:pt idx="5">
                  <c:v>YDR389W</c:v>
                </c:pt>
                <c:pt idx="6">
                  <c:v>YDR525W-A</c:v>
                </c:pt>
                <c:pt idx="7">
                  <c:v>YFL033C</c:v>
                </c:pt>
                <c:pt idx="8">
                  <c:v>YGR211W</c:v>
                </c:pt>
                <c:pt idx="9">
                  <c:v>YHR011W</c:v>
                </c:pt>
                <c:pt idx="10">
                  <c:v>YIL052C</c:v>
                </c:pt>
                <c:pt idx="11">
                  <c:v>YLL026W</c:v>
                </c:pt>
                <c:pt idx="12">
                  <c:v>YLR438C-A</c:v>
                </c:pt>
                <c:pt idx="13">
                  <c:v>YLR464W</c:v>
                </c:pt>
                <c:pt idx="14">
                  <c:v>YMR032W</c:v>
                </c:pt>
                <c:pt idx="15">
                  <c:v>YMR104C</c:v>
                </c:pt>
                <c:pt idx="16">
                  <c:v>YNL336W</c:v>
                </c:pt>
                <c:pt idx="17">
                  <c:v>YNL269W</c:v>
                </c:pt>
                <c:pt idx="18">
                  <c:v>YNR062C</c:v>
                </c:pt>
                <c:pt idx="19">
                  <c:v>YOR140W</c:v>
                </c:pt>
                <c:pt idx="20">
                  <c:v>YOR262W</c:v>
                </c:pt>
                <c:pt idx="21">
                  <c:v>YOR356W</c:v>
                </c:pt>
              </c:strCache>
            </c:strRef>
          </c:cat>
          <c:val>
            <c:numRef>
              <c:f>Sheet1!$B$8:$W$8</c:f>
              <c:numCache>
                <c:formatCode>General</c:formatCode>
                <c:ptCount val="22"/>
                <c:pt idx="0">
                  <c:v>0.18251665198364461</c:v>
                </c:pt>
                <c:pt idx="1">
                  <c:v>0.36541303404789138</c:v>
                </c:pt>
                <c:pt idx="2">
                  <c:v>0.25243782439917201</c:v>
                </c:pt>
                <c:pt idx="3">
                  <c:v>0.77057110835840714</c:v>
                </c:pt>
                <c:pt idx="4">
                  <c:v>0.49578962956807682</c:v>
                </c:pt>
                <c:pt idx="5">
                  <c:v>0.55980644432711979</c:v>
                </c:pt>
                <c:pt idx="6">
                  <c:v>0.68169580019548248</c:v>
                </c:pt>
                <c:pt idx="7">
                  <c:v>1.0188911966167209</c:v>
                </c:pt>
                <c:pt idx="8">
                  <c:v>0.29264022610630863</c:v>
                </c:pt>
                <c:pt idx="9">
                  <c:v>0.90281356458718787</c:v>
                </c:pt>
                <c:pt idx="10">
                  <c:v>0.61916679110870043</c:v>
                </c:pt>
                <c:pt idx="11">
                  <c:v>1.0364855474984684</c:v>
                </c:pt>
                <c:pt idx="12">
                  <c:v>0.86904332042850918</c:v>
                </c:pt>
                <c:pt idx="13">
                  <c:v>0.66094402456987833</c:v>
                </c:pt>
                <c:pt idx="14">
                  <c:v>1.0899031944061226</c:v>
                </c:pt>
                <c:pt idx="15">
                  <c:v>1.5044122927611907</c:v>
                </c:pt>
                <c:pt idx="16">
                  <c:v>0.92543271136065852</c:v>
                </c:pt>
                <c:pt idx="17">
                  <c:v>0.81524183955277096</c:v>
                </c:pt>
                <c:pt idx="18">
                  <c:v>0.42484249956932424</c:v>
                </c:pt>
                <c:pt idx="19">
                  <c:v>0.75116408970700044</c:v>
                </c:pt>
                <c:pt idx="20">
                  <c:v>0.71187705173501559</c:v>
                </c:pt>
                <c:pt idx="21">
                  <c:v>0.46290883402470312</c:v>
                </c:pt>
              </c:numCache>
            </c:numRef>
          </c:val>
        </c:ser>
        <c:axId val="203982336"/>
        <c:axId val="203983872"/>
      </c:barChart>
      <c:catAx>
        <c:axId val="203982336"/>
        <c:scaling>
          <c:orientation val="minMax"/>
        </c:scaling>
        <c:axPos val="l"/>
        <c:tickLblPos val="nextTo"/>
        <c:crossAx val="203983872"/>
        <c:crosses val="autoZero"/>
        <c:auto val="1"/>
        <c:lblAlgn val="ctr"/>
        <c:lblOffset val="100"/>
      </c:catAx>
      <c:valAx>
        <c:axId val="203983872"/>
        <c:scaling>
          <c:orientation val="minMax"/>
        </c:scaling>
        <c:axPos val="b"/>
        <c:majorGridlines/>
        <c:numFmt formatCode="General" sourceLinked="1"/>
        <c:tickLblPos val="nextTo"/>
        <c:crossAx val="203982336"/>
        <c:crosses val="autoZero"/>
        <c:crossBetween val="between"/>
      </c:valAx>
    </c:plotArea>
    <c:legend>
      <c:legendPos val="r"/>
      <c:layout/>
    </c:legend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C7CE9-00B8-49EA-8C33-2E687BCDD571}" type="datetimeFigureOut">
              <a:rPr kumimoji="1" lang="ja-JP" altLang="en-US" smtClean="0"/>
              <a:t>2010/12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A5C10-A807-4DAF-8F73-A9B1389AC7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C7CE9-00B8-49EA-8C33-2E687BCDD571}" type="datetimeFigureOut">
              <a:rPr kumimoji="1" lang="ja-JP" altLang="en-US" smtClean="0"/>
              <a:t>2010/12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A5C10-A807-4DAF-8F73-A9B1389AC7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C7CE9-00B8-49EA-8C33-2E687BCDD571}" type="datetimeFigureOut">
              <a:rPr kumimoji="1" lang="ja-JP" altLang="en-US" smtClean="0"/>
              <a:t>2010/12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A5C10-A807-4DAF-8F73-A9B1389AC7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C7CE9-00B8-49EA-8C33-2E687BCDD571}" type="datetimeFigureOut">
              <a:rPr kumimoji="1" lang="ja-JP" altLang="en-US" smtClean="0"/>
              <a:t>2010/12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A5C10-A807-4DAF-8F73-A9B1389AC7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C7CE9-00B8-49EA-8C33-2E687BCDD571}" type="datetimeFigureOut">
              <a:rPr kumimoji="1" lang="ja-JP" altLang="en-US" smtClean="0"/>
              <a:t>2010/12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A5C10-A807-4DAF-8F73-A9B1389AC7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C7CE9-00B8-49EA-8C33-2E687BCDD571}" type="datetimeFigureOut">
              <a:rPr kumimoji="1" lang="ja-JP" altLang="en-US" smtClean="0"/>
              <a:t>2010/12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A5C10-A807-4DAF-8F73-A9B1389AC7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C7CE9-00B8-49EA-8C33-2E687BCDD571}" type="datetimeFigureOut">
              <a:rPr kumimoji="1" lang="ja-JP" altLang="en-US" smtClean="0"/>
              <a:t>2010/12/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A5C10-A807-4DAF-8F73-A9B1389AC7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C7CE9-00B8-49EA-8C33-2E687BCDD571}" type="datetimeFigureOut">
              <a:rPr kumimoji="1" lang="ja-JP" altLang="en-US" smtClean="0"/>
              <a:t>2010/12/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A5C10-A807-4DAF-8F73-A9B1389AC7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C7CE9-00B8-49EA-8C33-2E687BCDD571}" type="datetimeFigureOut">
              <a:rPr kumimoji="1" lang="ja-JP" altLang="en-US" smtClean="0"/>
              <a:t>2010/12/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A5C10-A807-4DAF-8F73-A9B1389AC7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C7CE9-00B8-49EA-8C33-2E687BCDD571}" type="datetimeFigureOut">
              <a:rPr kumimoji="1" lang="ja-JP" altLang="en-US" smtClean="0"/>
              <a:t>2010/12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A5C10-A807-4DAF-8F73-A9B1389AC7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C7CE9-00B8-49EA-8C33-2E687BCDD571}" type="datetimeFigureOut">
              <a:rPr kumimoji="1" lang="ja-JP" altLang="en-US" smtClean="0"/>
              <a:t>2010/12/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4A5C10-A807-4DAF-8F73-A9B1389AC7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3C7CE9-00B8-49EA-8C33-2E687BCDD571}" type="datetimeFigureOut">
              <a:rPr kumimoji="1" lang="ja-JP" altLang="en-US" smtClean="0"/>
              <a:t>2010/12/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4A5C10-A807-4DAF-8F73-A9B1389AC752}" type="slidenum">
              <a:rPr kumimoji="1" lang="ja-JP" altLang="en-US" smtClean="0"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/>
          <p:nvPr/>
        </p:nvGraphicFramePr>
        <p:xfrm>
          <a:off x="0" y="179512"/>
          <a:ext cx="6858000" cy="78488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6027583" y="873917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Fig. S3</a:t>
            </a:r>
            <a:endParaRPr kumimoji="1" lang="ja-JP" alt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3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Nishida</dc:creator>
  <cp:lastModifiedBy>Nishida</cp:lastModifiedBy>
  <cp:revision>2</cp:revision>
  <dcterms:created xsi:type="dcterms:W3CDTF">2010-12-08T01:41:25Z</dcterms:created>
  <dcterms:modified xsi:type="dcterms:W3CDTF">2010-12-08T01:57:34Z</dcterms:modified>
</cp:coreProperties>
</file>